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83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810" y="648"/>
      </p:cViewPr>
      <p:guideLst>
        <p:guide orient="horz" pos="3121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Shivaprasad\Desktop\Soham\403%20corrected%20abundance%20graph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6107674040744911E-2"/>
          <c:y val="6.6781007707927123E-2"/>
          <c:w val="0.86149418822647172"/>
          <c:h val="0.71568407988444782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403 floral'!$C$5</c:f>
              <c:strCache>
                <c:ptCount val="1"/>
                <c:pt idx="0">
                  <c:v>UUAGAUUCACGCACAAACUCG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403 floral'!$B$6:$B$41</c:f>
              <c:strCache>
                <c:ptCount val="36"/>
                <c:pt idx="0">
                  <c:v>cco</c:v>
                </c:pt>
                <c:pt idx="1">
                  <c:v>ppa</c:v>
                </c:pt>
                <c:pt idx="2">
                  <c:v>sma</c:v>
                </c:pt>
                <c:pt idx="3">
                  <c:v>mqu</c:v>
                </c:pt>
                <c:pt idx="4">
                  <c:v>cru</c:v>
                </c:pt>
                <c:pt idx="5">
                  <c:v>gbi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a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pvu</c:v>
                </c:pt>
                <c:pt idx="28">
                  <c:v>sla</c:v>
                </c:pt>
                <c:pt idx="29">
                  <c:v>lsa</c:v>
                </c:pt>
                <c:pt idx="30">
                  <c:v>mgu</c:v>
                </c:pt>
                <c:pt idx="31">
                  <c:v>nta</c:v>
                </c:pt>
                <c:pt idx="32">
                  <c:v>phy</c:v>
                </c:pt>
                <c:pt idx="33">
                  <c:v>can</c:v>
                </c:pt>
                <c:pt idx="34">
                  <c:v>sly</c:v>
                </c:pt>
                <c:pt idx="35">
                  <c:v>stu</c:v>
                </c:pt>
              </c:strCache>
            </c:strRef>
          </c:cat>
          <c:val>
            <c:numRef>
              <c:f>'403 floral'!$C$6:$C$41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299.38378263710922</c:v>
                </c:pt>
                <c:pt idx="21">
                  <c:v>309.05801662548248</c:v>
                </c:pt>
                <c:pt idx="23">
                  <c:v>9.6739443854299161</c:v>
                </c:pt>
                <c:pt idx="24">
                  <c:v>35.725636963468688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30.910823068033928</c:v>
                </c:pt>
                <c:pt idx="29">
                  <c:v>76.44262142257854</c:v>
                </c:pt>
                <c:pt idx="30">
                  <c:v>27.392396073756565</c:v>
                </c:pt>
                <c:pt idx="31">
                  <c:v>89.018543742425379</c:v>
                </c:pt>
                <c:pt idx="32">
                  <c:v>51.320661758801343</c:v>
                </c:pt>
                <c:pt idx="33">
                  <c:v>31.443851343532881</c:v>
                </c:pt>
              </c:numCache>
            </c:numRef>
          </c:val>
        </c:ser>
        <c:ser>
          <c:idx val="2"/>
          <c:order val="1"/>
          <c:tx>
            <c:strRef>
              <c:f>'403 floral'!$D$5</c:f>
              <c:strCache>
                <c:ptCount val="1"/>
                <c:pt idx="0">
                  <c:v>UUAGAUUCACGCAGAAACUCG</c:v>
                </c:pt>
              </c:strCache>
            </c:strRef>
          </c:tx>
          <c:invertIfNegative val="0"/>
          <c:dPt>
            <c:idx val="23"/>
            <c:invertIfNegative val="0"/>
            <c:bubble3D val="0"/>
            <c:spPr>
              <a:solidFill>
                <a:srgbClr val="7030A0"/>
              </a:solidFill>
            </c:spPr>
          </c:dPt>
          <c:cat>
            <c:strRef>
              <c:f>'403 floral'!$B$6:$B$41</c:f>
              <c:strCache>
                <c:ptCount val="36"/>
                <c:pt idx="0">
                  <c:v>cco</c:v>
                </c:pt>
                <c:pt idx="1">
                  <c:v>ppa</c:v>
                </c:pt>
                <c:pt idx="2">
                  <c:v>sma</c:v>
                </c:pt>
                <c:pt idx="3">
                  <c:v>mqu</c:v>
                </c:pt>
                <c:pt idx="4">
                  <c:v>cru</c:v>
                </c:pt>
                <c:pt idx="5">
                  <c:v>gbi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a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pvu</c:v>
                </c:pt>
                <c:pt idx="28">
                  <c:v>sla</c:v>
                </c:pt>
                <c:pt idx="29">
                  <c:v>lsa</c:v>
                </c:pt>
                <c:pt idx="30">
                  <c:v>mgu</c:v>
                </c:pt>
                <c:pt idx="31">
                  <c:v>nta</c:v>
                </c:pt>
                <c:pt idx="32">
                  <c:v>phy</c:v>
                </c:pt>
                <c:pt idx="33">
                  <c:v>can</c:v>
                </c:pt>
                <c:pt idx="34">
                  <c:v>sly</c:v>
                </c:pt>
                <c:pt idx="35">
                  <c:v>stu</c:v>
                </c:pt>
              </c:strCache>
            </c:strRef>
          </c:cat>
          <c:val>
            <c:numRef>
              <c:f>'403 floral'!$D$6:$D$41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3">
                  <c:v>145.4212285035594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</c:numCache>
            </c:numRef>
          </c:val>
        </c:ser>
        <c:ser>
          <c:idx val="3"/>
          <c:order val="2"/>
          <c:tx>
            <c:strRef>
              <c:f>'403 floral'!$E$5</c:f>
              <c:strCache>
                <c:ptCount val="1"/>
                <c:pt idx="0">
                  <c:v>CUAGAUUCACGCACAAACUCG</c:v>
                </c:pt>
              </c:strCache>
            </c:strRef>
          </c:tx>
          <c:spPr>
            <a:solidFill>
              <a:srgbClr val="FFC000"/>
            </a:solidFill>
          </c:spPr>
          <c:invertIfNegative val="0"/>
          <c:cat>
            <c:strRef>
              <c:f>'403 floral'!$B$6:$B$41</c:f>
              <c:strCache>
                <c:ptCount val="36"/>
                <c:pt idx="0">
                  <c:v>cco</c:v>
                </c:pt>
                <c:pt idx="1">
                  <c:v>ppa</c:v>
                </c:pt>
                <c:pt idx="2">
                  <c:v>sma</c:v>
                </c:pt>
                <c:pt idx="3">
                  <c:v>mqu</c:v>
                </c:pt>
                <c:pt idx="4">
                  <c:v>cru</c:v>
                </c:pt>
                <c:pt idx="5">
                  <c:v>gbi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a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pvu</c:v>
                </c:pt>
                <c:pt idx="28">
                  <c:v>sla</c:v>
                </c:pt>
                <c:pt idx="29">
                  <c:v>lsa</c:v>
                </c:pt>
                <c:pt idx="30">
                  <c:v>mgu</c:v>
                </c:pt>
                <c:pt idx="31">
                  <c:v>nta</c:v>
                </c:pt>
                <c:pt idx="32">
                  <c:v>phy</c:v>
                </c:pt>
                <c:pt idx="33">
                  <c:v>can</c:v>
                </c:pt>
                <c:pt idx="34">
                  <c:v>sly</c:v>
                </c:pt>
                <c:pt idx="35">
                  <c:v>stu</c:v>
                </c:pt>
              </c:strCache>
            </c:strRef>
          </c:cat>
          <c:val>
            <c:numRef>
              <c:f>'403 floral'!$E$6:$E$41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2">
                  <c:v>29.867873200279988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35">
                  <c:v>4.9593488374976369</c:v>
                </c:pt>
              </c:numCache>
            </c:numRef>
          </c:val>
        </c:ser>
        <c:ser>
          <c:idx val="4"/>
          <c:order val="3"/>
          <c:tx>
            <c:strRef>
              <c:f>'403 floral'!$F$5</c:f>
              <c:strCache>
                <c:ptCount val="1"/>
                <c:pt idx="0">
                  <c:v>UUAGAUUCACGCACAAACUCU</c:v>
                </c:pt>
              </c:strCache>
            </c:strRef>
          </c:tx>
          <c:invertIfNegative val="0"/>
          <c:cat>
            <c:strRef>
              <c:f>'403 floral'!$B$6:$B$41</c:f>
              <c:strCache>
                <c:ptCount val="36"/>
                <c:pt idx="0">
                  <c:v>cco</c:v>
                </c:pt>
                <c:pt idx="1">
                  <c:v>ppa</c:v>
                </c:pt>
                <c:pt idx="2">
                  <c:v>sma</c:v>
                </c:pt>
                <c:pt idx="3">
                  <c:v>mqu</c:v>
                </c:pt>
                <c:pt idx="4">
                  <c:v>cru</c:v>
                </c:pt>
                <c:pt idx="5">
                  <c:v>gbi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a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pvu</c:v>
                </c:pt>
                <c:pt idx="28">
                  <c:v>sla</c:v>
                </c:pt>
                <c:pt idx="29">
                  <c:v>lsa</c:v>
                </c:pt>
                <c:pt idx="30">
                  <c:v>mgu</c:v>
                </c:pt>
                <c:pt idx="31">
                  <c:v>nta</c:v>
                </c:pt>
                <c:pt idx="32">
                  <c:v>phy</c:v>
                </c:pt>
                <c:pt idx="33">
                  <c:v>can</c:v>
                </c:pt>
                <c:pt idx="34">
                  <c:v>sly</c:v>
                </c:pt>
                <c:pt idx="35">
                  <c:v>stu</c:v>
                </c:pt>
              </c:strCache>
            </c:strRef>
          </c:cat>
          <c:val>
            <c:numRef>
              <c:f>'403 floral'!$F$6:$F$41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3.686115777696422</c:v>
                </c:pt>
                <c:pt idx="23">
                  <c:v>0.31206272211064245</c:v>
                </c:pt>
                <c:pt idx="24">
                  <c:v>3.695755547945037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31">
                  <c:v>2.5025293421565369</c:v>
                </c:pt>
                <c:pt idx="32">
                  <c:v>0.30188624564000788</c:v>
                </c:pt>
                <c:pt idx="33">
                  <c:v>0.3144385134353288</c:v>
                </c:pt>
              </c:numCache>
            </c:numRef>
          </c:val>
        </c:ser>
        <c:ser>
          <c:idx val="1"/>
          <c:order val="4"/>
          <c:tx>
            <c:strRef>
              <c:f>'403 floral'!$G$5</c:f>
              <c:strCache>
                <c:ptCount val="1"/>
                <c:pt idx="0">
                  <c:v>UUAGAUUCACGCACAAACUCA</c:v>
                </c:pt>
              </c:strCache>
            </c:strRef>
          </c:tx>
          <c:invertIfNegative val="0"/>
          <c:cat>
            <c:strRef>
              <c:f>'403 floral'!$B$6:$B$41</c:f>
              <c:strCache>
                <c:ptCount val="36"/>
                <c:pt idx="0">
                  <c:v>cco</c:v>
                </c:pt>
                <c:pt idx="1">
                  <c:v>ppa</c:v>
                </c:pt>
                <c:pt idx="2">
                  <c:v>sma</c:v>
                </c:pt>
                <c:pt idx="3">
                  <c:v>mqu</c:v>
                </c:pt>
                <c:pt idx="4">
                  <c:v>cru</c:v>
                </c:pt>
                <c:pt idx="5">
                  <c:v>gbi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a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pvu</c:v>
                </c:pt>
                <c:pt idx="28">
                  <c:v>sla</c:v>
                </c:pt>
                <c:pt idx="29">
                  <c:v>lsa</c:v>
                </c:pt>
                <c:pt idx="30">
                  <c:v>mgu</c:v>
                </c:pt>
                <c:pt idx="31">
                  <c:v>nta</c:v>
                </c:pt>
                <c:pt idx="32">
                  <c:v>phy</c:v>
                </c:pt>
                <c:pt idx="33">
                  <c:v>can</c:v>
                </c:pt>
                <c:pt idx="34">
                  <c:v>sly</c:v>
                </c:pt>
                <c:pt idx="35">
                  <c:v>stu</c:v>
                </c:pt>
              </c:strCache>
            </c:strRef>
          </c:cat>
          <c:val>
            <c:numRef>
              <c:f>'403 floral'!$G$6:$G$41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20">
                  <c:v>1.7107644722120527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9">
                  <c:v>0.93222709051925046</c:v>
                </c:pt>
                <c:pt idx="31">
                  <c:v>2.1450251504198885</c:v>
                </c:pt>
              </c:numCache>
            </c:numRef>
          </c:val>
        </c:ser>
        <c:ser>
          <c:idx val="5"/>
          <c:order val="5"/>
          <c:tx>
            <c:strRef>
              <c:f>'403 floral'!$H$5</c:f>
              <c:strCache>
                <c:ptCount val="1"/>
                <c:pt idx="0">
                  <c:v>Rest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'403 floral'!$B$6:$B$41</c:f>
              <c:strCache>
                <c:ptCount val="36"/>
                <c:pt idx="0">
                  <c:v>cco</c:v>
                </c:pt>
                <c:pt idx="1">
                  <c:v>ppa</c:v>
                </c:pt>
                <c:pt idx="2">
                  <c:v>sma</c:v>
                </c:pt>
                <c:pt idx="3">
                  <c:v>mqu</c:v>
                </c:pt>
                <c:pt idx="4">
                  <c:v>cru</c:v>
                </c:pt>
                <c:pt idx="5">
                  <c:v>gbi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a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pvu</c:v>
                </c:pt>
                <c:pt idx="28">
                  <c:v>sla</c:v>
                </c:pt>
                <c:pt idx="29">
                  <c:v>lsa</c:v>
                </c:pt>
                <c:pt idx="30">
                  <c:v>mgu</c:v>
                </c:pt>
                <c:pt idx="31">
                  <c:v>nta</c:v>
                </c:pt>
                <c:pt idx="32">
                  <c:v>phy</c:v>
                </c:pt>
                <c:pt idx="33">
                  <c:v>can</c:v>
                </c:pt>
                <c:pt idx="34">
                  <c:v>sly</c:v>
                </c:pt>
                <c:pt idx="35">
                  <c:v>stu</c:v>
                </c:pt>
              </c:strCache>
            </c:strRef>
          </c:cat>
          <c:val>
            <c:numRef>
              <c:f>'403 floral'!$H$6:$H$41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3.686115777696422</c:v>
                </c:pt>
                <c:pt idx="21">
                  <c:v>18.387891149342209</c:v>
                </c:pt>
                <c:pt idx="22">
                  <c:v>0</c:v>
                </c:pt>
                <c:pt idx="23">
                  <c:v>0.62412544422128491</c:v>
                </c:pt>
                <c:pt idx="24">
                  <c:v>2.463837031963358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2.3777556206179944</c:v>
                </c:pt>
                <c:pt idx="29">
                  <c:v>5.5933625431155027</c:v>
                </c:pt>
                <c:pt idx="30">
                  <c:v>4.5653993456260942</c:v>
                </c:pt>
                <c:pt idx="31">
                  <c:v>5.0050586843130738</c:v>
                </c:pt>
                <c:pt idx="32">
                  <c:v>5.1320661758801345</c:v>
                </c:pt>
                <c:pt idx="33">
                  <c:v>2.5155081074826304</c:v>
                </c:pt>
                <c:pt idx="34">
                  <c:v>0</c:v>
                </c:pt>
                <c:pt idx="35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1"/>
        <c:overlap val="100"/>
        <c:axId val="33524352"/>
        <c:axId val="33534336"/>
      </c:barChart>
      <c:catAx>
        <c:axId val="33524352"/>
        <c:scaling>
          <c:orientation val="minMax"/>
        </c:scaling>
        <c:delete val="0"/>
        <c:axPos val="b"/>
        <c:majorTickMark val="out"/>
        <c:minorTickMark val="none"/>
        <c:tickLblPos val="nextTo"/>
        <c:crossAx val="33534336"/>
        <c:crosses val="autoZero"/>
        <c:auto val="1"/>
        <c:lblAlgn val="ctr"/>
        <c:lblOffset val="100"/>
        <c:noMultiLvlLbl val="0"/>
      </c:catAx>
      <c:valAx>
        <c:axId val="33534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35243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7770966129233842"/>
          <c:y val="0.17526405318804955"/>
          <c:w val="0.31982033495813023"/>
          <c:h val="0.35610493566153606"/>
        </c:manualLayout>
      </c:layout>
      <c:overlay val="0"/>
      <c:txPr>
        <a:bodyPr/>
        <a:lstStyle/>
        <a:p>
          <a:pPr>
            <a:defRPr sz="9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2511843031816139E-2"/>
          <c:y val="0.1147873419231687"/>
          <c:w val="0.91758231925554767"/>
          <c:h val="0.6632629444046767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403 floral'!$C$5</c:f>
              <c:strCache>
                <c:ptCount val="1"/>
                <c:pt idx="0">
                  <c:v>UUAGAUUCACGCACAAACUCG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403 floral'!$B$6:$B$41</c:f>
              <c:strCache>
                <c:ptCount val="36"/>
                <c:pt idx="0">
                  <c:v>cco</c:v>
                </c:pt>
                <c:pt idx="1">
                  <c:v>ppa</c:v>
                </c:pt>
                <c:pt idx="2">
                  <c:v>sma</c:v>
                </c:pt>
                <c:pt idx="3">
                  <c:v>mqu</c:v>
                </c:pt>
                <c:pt idx="4">
                  <c:v>cru</c:v>
                </c:pt>
                <c:pt idx="5">
                  <c:v>gbi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a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pvu</c:v>
                </c:pt>
                <c:pt idx="28">
                  <c:v>sla</c:v>
                </c:pt>
                <c:pt idx="29">
                  <c:v>lsa</c:v>
                </c:pt>
                <c:pt idx="30">
                  <c:v>mgu</c:v>
                </c:pt>
                <c:pt idx="31">
                  <c:v>nta</c:v>
                </c:pt>
                <c:pt idx="32">
                  <c:v>phy</c:v>
                </c:pt>
                <c:pt idx="33">
                  <c:v>can</c:v>
                </c:pt>
                <c:pt idx="34">
                  <c:v>sly</c:v>
                </c:pt>
                <c:pt idx="35">
                  <c:v>stu</c:v>
                </c:pt>
              </c:strCache>
            </c:strRef>
          </c:cat>
          <c:val>
            <c:numRef>
              <c:f>'403 floral'!$C$6:$C$41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299.38378263710922</c:v>
                </c:pt>
                <c:pt idx="21">
                  <c:v>309.05801662548248</c:v>
                </c:pt>
                <c:pt idx="23">
                  <c:v>9.6739443854299161</c:v>
                </c:pt>
                <c:pt idx="24">
                  <c:v>35.725636963468688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30.910823068033928</c:v>
                </c:pt>
                <c:pt idx="29">
                  <c:v>76.44262142257854</c:v>
                </c:pt>
                <c:pt idx="30">
                  <c:v>27.392396073756565</c:v>
                </c:pt>
                <c:pt idx="31">
                  <c:v>89.018543742425379</c:v>
                </c:pt>
                <c:pt idx="32">
                  <c:v>51.320661758801343</c:v>
                </c:pt>
                <c:pt idx="33">
                  <c:v>31.443851343532881</c:v>
                </c:pt>
              </c:numCache>
            </c:numRef>
          </c:val>
        </c:ser>
        <c:ser>
          <c:idx val="2"/>
          <c:order val="1"/>
          <c:tx>
            <c:strRef>
              <c:f>'403 floral'!$D$5</c:f>
              <c:strCache>
                <c:ptCount val="1"/>
                <c:pt idx="0">
                  <c:v>UUAGAUUCACGCAGAAACUCG</c:v>
                </c:pt>
              </c:strCache>
            </c:strRef>
          </c:tx>
          <c:invertIfNegative val="0"/>
          <c:dPt>
            <c:idx val="23"/>
            <c:invertIfNegative val="0"/>
            <c:bubble3D val="0"/>
            <c:spPr>
              <a:solidFill>
                <a:srgbClr val="7030A0"/>
              </a:solidFill>
            </c:spPr>
          </c:dPt>
          <c:cat>
            <c:strRef>
              <c:f>'403 floral'!$B$6:$B$41</c:f>
              <c:strCache>
                <c:ptCount val="36"/>
                <c:pt idx="0">
                  <c:v>cco</c:v>
                </c:pt>
                <c:pt idx="1">
                  <c:v>ppa</c:v>
                </c:pt>
                <c:pt idx="2">
                  <c:v>sma</c:v>
                </c:pt>
                <c:pt idx="3">
                  <c:v>mqu</c:v>
                </c:pt>
                <c:pt idx="4">
                  <c:v>cru</c:v>
                </c:pt>
                <c:pt idx="5">
                  <c:v>gbi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a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pvu</c:v>
                </c:pt>
                <c:pt idx="28">
                  <c:v>sla</c:v>
                </c:pt>
                <c:pt idx="29">
                  <c:v>lsa</c:v>
                </c:pt>
                <c:pt idx="30">
                  <c:v>mgu</c:v>
                </c:pt>
                <c:pt idx="31">
                  <c:v>nta</c:v>
                </c:pt>
                <c:pt idx="32">
                  <c:v>phy</c:v>
                </c:pt>
                <c:pt idx="33">
                  <c:v>can</c:v>
                </c:pt>
                <c:pt idx="34">
                  <c:v>sly</c:v>
                </c:pt>
                <c:pt idx="35">
                  <c:v>stu</c:v>
                </c:pt>
              </c:strCache>
            </c:strRef>
          </c:cat>
          <c:val>
            <c:numRef>
              <c:f>'403 floral'!$D$6:$D$41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3">
                  <c:v>145.4212285035594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</c:numCache>
            </c:numRef>
          </c:val>
        </c:ser>
        <c:ser>
          <c:idx val="3"/>
          <c:order val="2"/>
          <c:tx>
            <c:strRef>
              <c:f>'403 floral'!$E$5</c:f>
              <c:strCache>
                <c:ptCount val="1"/>
                <c:pt idx="0">
                  <c:v>CUAGAUUCACGCACAAACUCG</c:v>
                </c:pt>
              </c:strCache>
            </c:strRef>
          </c:tx>
          <c:invertIfNegative val="0"/>
          <c:dPt>
            <c:idx val="22"/>
            <c:invertIfNegative val="0"/>
            <c:bubble3D val="0"/>
            <c:spPr>
              <a:solidFill>
                <a:srgbClr val="FFC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C000"/>
              </a:solidFill>
            </c:spPr>
          </c:dPt>
          <c:cat>
            <c:strRef>
              <c:f>'403 floral'!$B$6:$B$41</c:f>
              <c:strCache>
                <c:ptCount val="36"/>
                <c:pt idx="0">
                  <c:v>cco</c:v>
                </c:pt>
                <c:pt idx="1">
                  <c:v>ppa</c:v>
                </c:pt>
                <c:pt idx="2">
                  <c:v>sma</c:v>
                </c:pt>
                <c:pt idx="3">
                  <c:v>mqu</c:v>
                </c:pt>
                <c:pt idx="4">
                  <c:v>cru</c:v>
                </c:pt>
                <c:pt idx="5">
                  <c:v>gbi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a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pvu</c:v>
                </c:pt>
                <c:pt idx="28">
                  <c:v>sla</c:v>
                </c:pt>
                <c:pt idx="29">
                  <c:v>lsa</c:v>
                </c:pt>
                <c:pt idx="30">
                  <c:v>mgu</c:v>
                </c:pt>
                <c:pt idx="31">
                  <c:v>nta</c:v>
                </c:pt>
                <c:pt idx="32">
                  <c:v>phy</c:v>
                </c:pt>
                <c:pt idx="33">
                  <c:v>can</c:v>
                </c:pt>
                <c:pt idx="34">
                  <c:v>sly</c:v>
                </c:pt>
                <c:pt idx="35">
                  <c:v>stu</c:v>
                </c:pt>
              </c:strCache>
            </c:strRef>
          </c:cat>
          <c:val>
            <c:numRef>
              <c:f>'403 floral'!$E$6:$E$41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2">
                  <c:v>29.867873200279988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35">
                  <c:v>4.9593488374976369</c:v>
                </c:pt>
              </c:numCache>
            </c:numRef>
          </c:val>
        </c:ser>
        <c:ser>
          <c:idx val="4"/>
          <c:order val="3"/>
          <c:tx>
            <c:strRef>
              <c:f>'403 floral'!$F$5</c:f>
              <c:strCache>
                <c:ptCount val="1"/>
                <c:pt idx="0">
                  <c:v>UUAGAUUCACGCACAAACUCU</c:v>
                </c:pt>
              </c:strCache>
            </c:strRef>
          </c:tx>
          <c:invertIfNegative val="0"/>
          <c:cat>
            <c:strRef>
              <c:f>'403 floral'!$B$6:$B$41</c:f>
              <c:strCache>
                <c:ptCount val="36"/>
                <c:pt idx="0">
                  <c:v>cco</c:v>
                </c:pt>
                <c:pt idx="1">
                  <c:v>ppa</c:v>
                </c:pt>
                <c:pt idx="2">
                  <c:v>sma</c:v>
                </c:pt>
                <c:pt idx="3">
                  <c:v>mqu</c:v>
                </c:pt>
                <c:pt idx="4">
                  <c:v>cru</c:v>
                </c:pt>
                <c:pt idx="5">
                  <c:v>gbi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a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pvu</c:v>
                </c:pt>
                <c:pt idx="28">
                  <c:v>sla</c:v>
                </c:pt>
                <c:pt idx="29">
                  <c:v>lsa</c:v>
                </c:pt>
                <c:pt idx="30">
                  <c:v>mgu</c:v>
                </c:pt>
                <c:pt idx="31">
                  <c:v>nta</c:v>
                </c:pt>
                <c:pt idx="32">
                  <c:v>phy</c:v>
                </c:pt>
                <c:pt idx="33">
                  <c:v>can</c:v>
                </c:pt>
                <c:pt idx="34">
                  <c:v>sly</c:v>
                </c:pt>
                <c:pt idx="35">
                  <c:v>stu</c:v>
                </c:pt>
              </c:strCache>
            </c:strRef>
          </c:cat>
          <c:val>
            <c:numRef>
              <c:f>'403 floral'!$F$6:$F$41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3.686115777696422</c:v>
                </c:pt>
                <c:pt idx="23">
                  <c:v>0.31206272211064245</c:v>
                </c:pt>
                <c:pt idx="24">
                  <c:v>3.695755547945037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31">
                  <c:v>2.5025293421565369</c:v>
                </c:pt>
                <c:pt idx="32">
                  <c:v>0.30188624564000788</c:v>
                </c:pt>
                <c:pt idx="33">
                  <c:v>0.3144385134353288</c:v>
                </c:pt>
              </c:numCache>
            </c:numRef>
          </c:val>
        </c:ser>
        <c:ser>
          <c:idx val="1"/>
          <c:order val="4"/>
          <c:tx>
            <c:strRef>
              <c:f>'403 floral'!$G$5</c:f>
              <c:strCache>
                <c:ptCount val="1"/>
                <c:pt idx="0">
                  <c:v>UUAGAUUCACGCACAAACUCA</c:v>
                </c:pt>
              </c:strCache>
            </c:strRef>
          </c:tx>
          <c:invertIfNegative val="0"/>
          <c:cat>
            <c:strRef>
              <c:f>'403 floral'!$B$6:$B$41</c:f>
              <c:strCache>
                <c:ptCount val="36"/>
                <c:pt idx="0">
                  <c:v>cco</c:v>
                </c:pt>
                <c:pt idx="1">
                  <c:v>ppa</c:v>
                </c:pt>
                <c:pt idx="2">
                  <c:v>sma</c:v>
                </c:pt>
                <c:pt idx="3">
                  <c:v>mqu</c:v>
                </c:pt>
                <c:pt idx="4">
                  <c:v>cru</c:v>
                </c:pt>
                <c:pt idx="5">
                  <c:v>gbi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a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pvu</c:v>
                </c:pt>
                <c:pt idx="28">
                  <c:v>sla</c:v>
                </c:pt>
                <c:pt idx="29">
                  <c:v>lsa</c:v>
                </c:pt>
                <c:pt idx="30">
                  <c:v>mgu</c:v>
                </c:pt>
                <c:pt idx="31">
                  <c:v>nta</c:v>
                </c:pt>
                <c:pt idx="32">
                  <c:v>phy</c:v>
                </c:pt>
                <c:pt idx="33">
                  <c:v>can</c:v>
                </c:pt>
                <c:pt idx="34">
                  <c:v>sly</c:v>
                </c:pt>
                <c:pt idx="35">
                  <c:v>stu</c:v>
                </c:pt>
              </c:strCache>
            </c:strRef>
          </c:cat>
          <c:val>
            <c:numRef>
              <c:f>'403 floral'!$G$6:$G$41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20">
                  <c:v>1.7107644722120527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9">
                  <c:v>0.93222709051925046</c:v>
                </c:pt>
                <c:pt idx="31">
                  <c:v>2.1450251504198885</c:v>
                </c:pt>
              </c:numCache>
            </c:numRef>
          </c:val>
        </c:ser>
        <c:ser>
          <c:idx val="5"/>
          <c:order val="5"/>
          <c:tx>
            <c:strRef>
              <c:f>'403 floral'!$H$5</c:f>
              <c:strCache>
                <c:ptCount val="1"/>
                <c:pt idx="0">
                  <c:v>Rest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'403 floral'!$B$6:$B$41</c:f>
              <c:strCache>
                <c:ptCount val="36"/>
                <c:pt idx="0">
                  <c:v>cco</c:v>
                </c:pt>
                <c:pt idx="1">
                  <c:v>ppa</c:v>
                </c:pt>
                <c:pt idx="2">
                  <c:v>sma</c:v>
                </c:pt>
                <c:pt idx="3">
                  <c:v>mqu</c:v>
                </c:pt>
                <c:pt idx="4">
                  <c:v>cru</c:v>
                </c:pt>
                <c:pt idx="5">
                  <c:v>gbi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a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pvu</c:v>
                </c:pt>
                <c:pt idx="28">
                  <c:v>sla</c:v>
                </c:pt>
                <c:pt idx="29">
                  <c:v>lsa</c:v>
                </c:pt>
                <c:pt idx="30">
                  <c:v>mgu</c:v>
                </c:pt>
                <c:pt idx="31">
                  <c:v>nta</c:v>
                </c:pt>
                <c:pt idx="32">
                  <c:v>phy</c:v>
                </c:pt>
                <c:pt idx="33">
                  <c:v>can</c:v>
                </c:pt>
                <c:pt idx="34">
                  <c:v>sly</c:v>
                </c:pt>
                <c:pt idx="35">
                  <c:v>stu</c:v>
                </c:pt>
              </c:strCache>
            </c:strRef>
          </c:cat>
          <c:val>
            <c:numRef>
              <c:f>'403 floral'!$H$6:$H$41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3.686115777696422</c:v>
                </c:pt>
                <c:pt idx="21">
                  <c:v>18.387891149342209</c:v>
                </c:pt>
                <c:pt idx="22">
                  <c:v>0</c:v>
                </c:pt>
                <c:pt idx="23">
                  <c:v>0.62412544422128491</c:v>
                </c:pt>
                <c:pt idx="24">
                  <c:v>2.463837031963358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2.3777556206179944</c:v>
                </c:pt>
                <c:pt idx="29">
                  <c:v>5.5933625431155027</c:v>
                </c:pt>
                <c:pt idx="30">
                  <c:v>4.5653993456260942</c:v>
                </c:pt>
                <c:pt idx="31">
                  <c:v>5.0050586843130738</c:v>
                </c:pt>
                <c:pt idx="32">
                  <c:v>5.1320661758801345</c:v>
                </c:pt>
                <c:pt idx="33">
                  <c:v>2.5155081074826304</c:v>
                </c:pt>
                <c:pt idx="34">
                  <c:v>0</c:v>
                </c:pt>
                <c:pt idx="35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1"/>
        <c:overlap val="100"/>
        <c:axId val="35161600"/>
        <c:axId val="35163136"/>
      </c:barChart>
      <c:catAx>
        <c:axId val="35161600"/>
        <c:scaling>
          <c:orientation val="minMax"/>
        </c:scaling>
        <c:delete val="0"/>
        <c:axPos val="b"/>
        <c:majorTickMark val="out"/>
        <c:minorTickMark val="none"/>
        <c:tickLblPos val="nextTo"/>
        <c:crossAx val="35163136"/>
        <c:crosses val="autoZero"/>
        <c:auto val="1"/>
        <c:lblAlgn val="ctr"/>
        <c:lblOffset val="100"/>
        <c:noMultiLvlLbl val="0"/>
      </c:catAx>
      <c:valAx>
        <c:axId val="35163136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crossAx val="3516160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5112145072774993"/>
          <c:y val="0.2108712234561079"/>
          <c:w val="0.39315549498620367"/>
          <c:h val="0.2525612956916971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619</cdr:x>
      <cdr:y>0</cdr:y>
    </cdr:from>
    <cdr:to>
      <cdr:x>0.689</cdr:x>
      <cdr:y>0.0865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676400" y="-2407443"/>
          <a:ext cx="2733781" cy="2400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kumimoji="0" lang="en-IN" sz="11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rPr>
            <a:t>Abundance of different isoforms in reproductive tissues</a:t>
          </a:r>
        </a:p>
        <a:p xmlns:a="http://schemas.openxmlformats.org/drawingml/2006/main">
          <a:endParaRPr lang="en-IN" sz="10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00539</cdr:x>
      <cdr:y>0.01074</cdr:y>
    </cdr:from>
    <cdr:to>
      <cdr:x>0.1381</cdr:x>
      <cdr:y>0.05431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50800" y="50800"/>
          <a:ext cx="1250102" cy="2060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IN" sz="1100" b="1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01112</cdr:x>
      <cdr:y>0.06609</cdr:y>
    </cdr:from>
    <cdr:to>
      <cdr:x>0.04762</cdr:x>
      <cdr:y>0.60915</cdr:y>
    </cdr:to>
    <cdr:sp macro="" textlink="">
      <cdr:nvSpPr>
        <cdr:cNvPr id="5" name="TextBox 1"/>
        <cdr:cNvSpPr txBox="1"/>
      </cdr:nvSpPr>
      <cdr:spPr>
        <a:xfrm xmlns:a="http://schemas.openxmlformats.org/drawingml/2006/main" rot="16200000">
          <a:off x="-565272" y="819805"/>
          <a:ext cx="1506521" cy="2336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100" b="1" dirty="0">
              <a:latin typeface="Arial" pitchFamily="34" charset="0"/>
              <a:cs typeface="Arial" pitchFamily="34" charset="0"/>
            </a:rPr>
            <a:t>Reads per million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8788</cdr:x>
      <cdr:y>0.00947</cdr:y>
    </cdr:from>
    <cdr:to>
      <cdr:x>0.76788</cdr:x>
      <cdr:y>0.10338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2413000" y="41275"/>
          <a:ext cx="4023410" cy="4092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kumimoji="0" lang="en-IN" sz="11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rPr>
            <a:t>% abundance of different isoforms in reproductive tissues</a:t>
          </a:r>
        </a:p>
        <a:p xmlns:a="http://schemas.openxmlformats.org/drawingml/2006/main">
          <a:endParaRPr lang="en-IN" sz="1000" dirty="0">
            <a:latin typeface="Arial" pitchFamily="34" charset="0"/>
            <a:cs typeface="Arial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7965BD-FD03-4C8F-A197-EC50D7697508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ABED53-BBA4-43C4-9D66-9DCD9637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7183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1" y="561343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1" y="39673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3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6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1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1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25" y="2217387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25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94" y="2217387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94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25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12" y="39443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25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5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1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5281996"/>
              </p:ext>
            </p:extLst>
          </p:nvPr>
        </p:nvGraphicFramePr>
        <p:xfrm>
          <a:off x="304800" y="838210"/>
          <a:ext cx="6400800" cy="27741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9554392"/>
              </p:ext>
            </p:extLst>
          </p:nvPr>
        </p:nvGraphicFramePr>
        <p:xfrm>
          <a:off x="533400" y="3810000"/>
          <a:ext cx="5943600" cy="3124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819400" y="172682"/>
            <a:ext cx="2667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8</a:t>
            </a:r>
            <a:endParaRPr lang="en-US" dirty="0"/>
          </a:p>
        </p:txBody>
      </p:sp>
      <p:sp>
        <p:nvSpPr>
          <p:cNvPr id="5" name="TextBox 1"/>
          <p:cNvSpPr txBox="1"/>
          <p:nvPr/>
        </p:nvSpPr>
        <p:spPr>
          <a:xfrm rot="16200000">
            <a:off x="-252177" y="5056143"/>
            <a:ext cx="1292043" cy="17807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IN" sz="1050" b="0" dirty="0">
                <a:latin typeface="Arial" pitchFamily="34" charset="0"/>
                <a:cs typeface="Arial" pitchFamily="34" charset="0"/>
              </a:rPr>
              <a:t>Reads per millio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07083" y="533400"/>
            <a:ext cx="7381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(A)</a:t>
            </a:r>
            <a:endParaRPr lang="en-US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507083" y="3657600"/>
            <a:ext cx="738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(B)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85593" y="6858000"/>
            <a:ext cx="63245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</a:t>
            </a:r>
            <a:r>
              <a:rPr lang="en-US" sz="1200" b="1" dirty="0" smtClean="0"/>
              <a:t>S8.</a:t>
            </a:r>
            <a:r>
              <a:rPr lang="en-US" sz="1200" dirty="0" smtClean="0"/>
              <a:t>  </a:t>
            </a:r>
            <a:r>
              <a:rPr lang="en-US" sz="1200" dirty="0"/>
              <a:t>Abundance and sequence diversity of </a:t>
            </a:r>
            <a:r>
              <a:rPr lang="en-US" sz="1200" dirty="0" smtClean="0"/>
              <a:t>miR403 </a:t>
            </a:r>
            <a:r>
              <a:rPr lang="en-US" sz="1200" dirty="0"/>
              <a:t>members across plant families in reproductive tissues.  </a:t>
            </a:r>
            <a:r>
              <a:rPr lang="en-US" sz="1200" b="1" dirty="0"/>
              <a:t>a</a:t>
            </a:r>
            <a:r>
              <a:rPr lang="en-US" sz="1200" dirty="0"/>
              <a:t>  abundance of </a:t>
            </a:r>
            <a:r>
              <a:rPr lang="en-US" sz="1200" dirty="0" smtClean="0"/>
              <a:t>miR403.  </a:t>
            </a:r>
            <a:r>
              <a:rPr lang="en-US" sz="1200" dirty="0"/>
              <a:t>Color bars represent most abundant forms of </a:t>
            </a:r>
            <a:r>
              <a:rPr lang="en-US" sz="1200" dirty="0" smtClean="0"/>
              <a:t>miR403 </a:t>
            </a:r>
            <a:r>
              <a:rPr lang="en-US" sz="1200" dirty="0"/>
              <a:t>in reproductive tissues. </a:t>
            </a:r>
            <a:r>
              <a:rPr lang="en-US" sz="1200" b="1" dirty="0" smtClean="0"/>
              <a:t>b</a:t>
            </a:r>
            <a:r>
              <a:rPr lang="en-US" sz="1200" dirty="0" smtClean="0"/>
              <a:t> </a:t>
            </a:r>
            <a:r>
              <a:rPr lang="en-US" sz="1200" dirty="0"/>
              <a:t>Percentage abundance of </a:t>
            </a:r>
            <a:r>
              <a:rPr lang="en-US" sz="1200" dirty="0" smtClean="0"/>
              <a:t>miR403 </a:t>
            </a:r>
            <a:r>
              <a:rPr lang="en-US" sz="1200" dirty="0"/>
              <a:t>across plant families.  </a:t>
            </a:r>
          </a:p>
        </p:txBody>
      </p:sp>
    </p:spTree>
    <p:extLst>
      <p:ext uri="{BB962C8B-B14F-4D97-AF65-F5344CB8AC3E}">
        <p14:creationId xmlns:p14="http://schemas.microsoft.com/office/powerpoint/2010/main" val="2596391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80</TotalTime>
  <Words>72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vaprasad</dc:creator>
  <cp:lastModifiedBy>Shivaprasad</cp:lastModifiedBy>
  <cp:revision>124</cp:revision>
  <dcterms:created xsi:type="dcterms:W3CDTF">2006-08-16T00:00:00Z</dcterms:created>
  <dcterms:modified xsi:type="dcterms:W3CDTF">2014-08-25T07:09:58Z</dcterms:modified>
</cp:coreProperties>
</file>